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1FF7F8-E2D6-4E24-A5DF-8BCF1B967706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1C98F9-D4B7-4DE9-8684-F3D4263FB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6882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980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319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4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71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23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864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013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430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000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05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80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014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533198" y="771114"/>
          <a:ext cx="8280654" cy="58216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40157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052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52134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3095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5510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549309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07324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545763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508751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</a:tblGrid>
              <a:tr h="64490">
                <a:tc gridSpan="4">
                  <a:txBody>
                    <a:bodyPr/>
                    <a:lstStyle/>
                    <a:p>
                      <a:pPr algn="ctr"/>
                      <a:r>
                        <a:rPr lang="en-US" sz="1600" baseline="0" dirty="0"/>
                        <a:t>AMY</a:t>
                      </a:r>
                      <a:endParaRPr lang="en-US" sz="1600" b="1" baseline="0" dirty="0">
                        <a:solidFill>
                          <a:schemeClr val="tx1"/>
                        </a:solidFill>
                      </a:endParaRP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>
                        <a:solidFill>
                          <a:schemeClr val="tx1"/>
                        </a:solidFill>
                      </a:endParaRP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 dirty="0">
                        <a:solidFill>
                          <a:schemeClr val="tx1"/>
                        </a:solidFill>
                      </a:endParaRP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1600" b="1" baseline="0"/>
                    </a:p>
                  </a:txBody>
                  <a:tcPr marR="0" marT="0" marB="0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600" baseline="0" dirty="0"/>
                        <a:t>ACC</a:t>
                      </a:r>
                      <a:endParaRPr lang="en-US" sz="1600" b="1" baseline="0" dirty="0">
                        <a:solidFill>
                          <a:schemeClr val="tx1"/>
                        </a:solidFill>
                      </a:endParaRP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 dirty="0">
                        <a:solidFill>
                          <a:schemeClr val="tx1"/>
                        </a:solidFill>
                      </a:endParaRP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8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baseline="0" dirty="0"/>
                        <a:t>2 weeks</a:t>
                      </a:r>
                      <a:endParaRPr lang="en-US" sz="16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baseline="0" dirty="0"/>
                        <a:t>5 weeks</a:t>
                      </a:r>
                      <a:endParaRPr lang="en-US" sz="16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endParaRPr lang="en-US" sz="1600" b="1" baseline="0"/>
                    </a:p>
                  </a:txBody>
                  <a:tcPr marR="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baseline="0" dirty="0"/>
                        <a:t>2 weeks</a:t>
                      </a:r>
                      <a:endParaRPr lang="en-US" sz="16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u="none" baseline="0" dirty="0"/>
                        <a:t>5 weeks</a:t>
                      </a:r>
                      <a:endParaRPr lang="en-US" sz="1600" b="1" u="none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olecular func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 value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olecular func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 value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olecular func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 value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olecular func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 value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ctin filament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9E-07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rotein binding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2E-1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0E-29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rotein binding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5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ctin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7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ion channel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9E-06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ion channel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8E-13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rotein kinase activity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0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etal ion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8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voltage-gated ion channel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5E-06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ucleotide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7E-10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transcription factor binding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6E-02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ctin-dependent ATPase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9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almodulin-dependent protein kinase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5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alcium ion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4.4E-10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sequence-specific DNA binding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1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GTPase</a:t>
                      </a:r>
                      <a:r>
                        <a:rPr lang="en-US" sz="1000" u="none" strike="noStrike" baseline="0" dirty="0">
                          <a:effectLst/>
                        </a:rPr>
                        <a:t> activator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1E-04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tassium channel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4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etal ion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7E-09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kinase activity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7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complex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5E-04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</a:t>
                      </a:r>
                      <a:r>
                        <a:rPr lang="en-US" sz="1000" u="none" strike="noStrike" baseline="0" dirty="0" err="1">
                          <a:effectLst/>
                        </a:rPr>
                        <a:t>homodimerization</a:t>
                      </a:r>
                      <a:r>
                        <a:rPr lang="en-US" sz="1000" u="none" strike="noStrike" baseline="0" dirty="0">
                          <a:effectLst/>
                        </a:rPr>
                        <a:t>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5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beta-catenin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2E-09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rotein serine/threonine kinase activity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4.6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unmethylated</a:t>
                      </a:r>
                      <a:r>
                        <a:rPr lang="en-US" sz="1000" u="none" strike="noStrike" baseline="0" dirty="0">
                          <a:effectLst/>
                        </a:rPr>
                        <a:t> </a:t>
                      </a:r>
                      <a:r>
                        <a:rPr lang="en-US" sz="1000" u="none" strike="noStrike" baseline="0" dirty="0" err="1">
                          <a:effectLst/>
                        </a:rPr>
                        <a:t>CpG</a:t>
                      </a:r>
                      <a:r>
                        <a:rPr lang="en-US" sz="1000" u="none" strike="noStrike" baseline="0" dirty="0">
                          <a:effectLst/>
                        </a:rPr>
                        <a:t>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6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alcium-dependent protein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5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transferase activity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0E-08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alcium ion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4.0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kinase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7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TP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7E-07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kinase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4.4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tyrosine kinase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9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kinase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7.8E-07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icrofilament motor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7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uropeptide hormone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1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kinase activity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9.4E-07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structural constituent of myelin sheath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8.9E-04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tyrosine phosphatase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2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voltage-gated ion channel activity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3E-06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Rab</a:t>
                      </a:r>
                      <a:r>
                        <a:rPr lang="en-US" sz="1000" u="none" strike="noStrike" baseline="0" dirty="0">
                          <a:effectLst/>
                        </a:rPr>
                        <a:t> </a:t>
                      </a:r>
                      <a:r>
                        <a:rPr lang="en-US" sz="1000" u="none" strike="noStrike" baseline="0" dirty="0" err="1">
                          <a:effectLst/>
                        </a:rPr>
                        <a:t>GTPase</a:t>
                      </a:r>
                      <a:r>
                        <a:rPr lang="en-US" sz="1000" u="none" strike="noStrike" baseline="0" dirty="0">
                          <a:effectLst/>
                        </a:rPr>
                        <a:t>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7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</a:t>
                      </a:r>
                      <a:r>
                        <a:rPr lang="en-US" sz="1000" u="none" strike="noStrike" baseline="0" dirty="0" err="1">
                          <a:effectLst/>
                        </a:rPr>
                        <a:t>heterodimerization</a:t>
                      </a:r>
                      <a:r>
                        <a:rPr lang="en-US" sz="1000" u="none" strike="noStrike" baseline="0" dirty="0">
                          <a:effectLst/>
                        </a:rPr>
                        <a:t>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9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kinase activity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4E-06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otor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2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uropeptide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3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Rab</a:t>
                      </a:r>
                      <a:r>
                        <a:rPr lang="en-US" sz="1000" u="none" strike="noStrike" baseline="0" dirty="0">
                          <a:effectLst/>
                        </a:rPr>
                        <a:t> </a:t>
                      </a:r>
                      <a:r>
                        <a:rPr lang="en-US" sz="1000" u="none" strike="noStrike" baseline="0" dirty="0" err="1">
                          <a:effectLst/>
                        </a:rPr>
                        <a:t>GTPase</a:t>
                      </a:r>
                      <a:r>
                        <a:rPr lang="en-US" sz="1000" u="none" strike="noStrike" baseline="0" dirty="0">
                          <a:effectLst/>
                        </a:rPr>
                        <a:t>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3E-06</a:t>
                      </a:r>
                      <a:endParaRPr lang="en-US" sz="1000" b="1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rotein domain specific binding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7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scaffold protein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4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GEF activity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4.0E-06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beta-catenin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4.9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rve growth factor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1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voltage-gated potassium channel activity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5.7E-06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transferase activity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8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voltage-gated potassium channel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5.9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almodulin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5E-05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zinc ion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6.1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four-way junction DNA binding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9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transcription factor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6.6E-05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ho GEF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6.5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kinase activity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9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serine/threonine kinase activity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6.8E-05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AP kinase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9.8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domain specific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6.1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adherin binding involved in cell-cell adhesion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9E-04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TP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0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DP bind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6.6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endParaRPr lang="en-US" sz="1000" b="1" baseline="0" dirty="0">
                        <a:latin typeface="+mn-lt"/>
                      </a:endParaRPr>
                    </a:p>
                  </a:txBody>
                  <a:tcPr marR="0" marT="0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zinc ion binding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9E-04</a:t>
                      </a:r>
                      <a:endParaRPr lang="en-US" sz="1000" b="1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R="9525" marT="0" marB="0" anchor="b"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</a:tbl>
          </a:graphicData>
        </a:graphic>
      </p:graphicFrame>
      <p:cxnSp>
        <p:nvCxnSpPr>
          <p:cNvPr id="12" name="Straight Connector 11"/>
          <p:cNvCxnSpPr/>
          <p:nvPr/>
        </p:nvCxnSpPr>
        <p:spPr>
          <a:xfrm>
            <a:off x="1625988" y="1233763"/>
            <a:ext cx="184022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1625988" y="1046615"/>
            <a:ext cx="39135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965AA4B-B240-40D1-B570-7A5D8EB7BD95}"/>
              </a:ext>
            </a:extLst>
          </p:cNvPr>
          <p:cNvSpPr txBox="1"/>
          <p:nvPr/>
        </p:nvSpPr>
        <p:spPr>
          <a:xfrm>
            <a:off x="1533198" y="332954"/>
            <a:ext cx="8482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Table </a:t>
            </a:r>
            <a:r>
              <a:rPr lang="en-US" sz="1400" b="1" dirty="0" smtClean="0"/>
              <a:t>S1. </a:t>
            </a:r>
            <a:r>
              <a:rPr lang="en-US" sz="1400" b="1" dirty="0"/>
              <a:t>Enriched molecular functions of regulated genes in AMY and ACC </a:t>
            </a:r>
            <a:r>
              <a:rPr lang="en-US" sz="1400" b="1" dirty="0">
                <a:solidFill>
                  <a:prstClr val="black"/>
                </a:solidFill>
              </a:rPr>
              <a:t>at 2 and 5 weeks post stress</a:t>
            </a:r>
            <a:r>
              <a:rPr lang="en-US" sz="1400" b="1" dirty="0"/>
              <a:t>. 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3596555" y="1237304"/>
            <a:ext cx="19430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5779782" y="1230213"/>
            <a:ext cx="19430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821242" y="1230211"/>
            <a:ext cx="19430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5797509" y="1039523"/>
            <a:ext cx="39135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625988" y="766157"/>
            <a:ext cx="8138262" cy="126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1641908" y="6788301"/>
            <a:ext cx="8138262" cy="126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98101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10</Words>
  <Application>Microsoft Office PowerPoint</Application>
  <PresentationFormat>Widescreen</PresentationFormat>
  <Paragraphs>1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SUH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IEI TANAKA</dc:creator>
  <cp:lastModifiedBy>YUMIN ZHANG</cp:lastModifiedBy>
  <cp:revision>17</cp:revision>
  <dcterms:created xsi:type="dcterms:W3CDTF">2019-03-07T14:38:56Z</dcterms:created>
  <dcterms:modified xsi:type="dcterms:W3CDTF">2019-03-07T22:25:48Z</dcterms:modified>
</cp:coreProperties>
</file>